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9BA98-B8B6-4464-9D59-FEB7D513C7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D29C17-F053-451D-85ED-BE219E2975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834AE-8FB1-479D-8293-AB3A98847E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65DAC-04CE-48F3-B6EA-AD7A5CF24F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E4A05-E79F-486D-836E-26E3F59C33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D0B0F-4129-4521-B917-B6C202D0F9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148BD-55D7-435A-9776-0C78266643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EB46C-0092-4A58-831E-D61709F05B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5A813-5ABF-4596-BD13-5646D4E67E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85CB1E-AEEA-48C6-A425-08B85BD0E5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C0954-EC64-4CED-A012-33FACF0294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FF9B3-53AD-4356-AE3C-D84BD3D40B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F571CE-F3DA-4D16-8693-93384F598FB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79"/>
          <p:cNvSpPr/>
          <p:nvPr/>
        </p:nvSpPr>
        <p:spPr>
          <a:xfrm>
            <a:off x="549360" y="4097160"/>
            <a:ext cx="57592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3. Validation of mRNA-Seq–based transcript quantification using real-time PCR (qPCR)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Twelve genes involved in CCM and photorespiration metabolism are selected for qPCR validation. The genes and qPCR primer sequences are listed in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l Table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The transcript levels at each time point after the onset of carbon limitation are included, and the correlation coefficient between the average qPCR-based transcript abundance and the mRNA-Seq based transcript abundance is 0.9497 (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1557360" y="1281240"/>
            <a:ext cx="3414600" cy="2646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6T02:16:16Z</dcterms:created>
  <dc:creator>weili</dc:creator>
  <dc:description/>
  <dc:language>en-US</dc:language>
  <cp:lastModifiedBy>Srividya S</cp:lastModifiedBy>
  <dcterms:modified xsi:type="dcterms:W3CDTF">2019-06-19T13:05:06Z</dcterms:modified>
  <cp:revision>535</cp:revision>
  <dc:subject/>
  <dc:title>Main figure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84</vt:lpwstr>
  </property>
</Properties>
</file>